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4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769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14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019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70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132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004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19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500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846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641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496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A7B78-A72F-4FFD-8B60-6F976E82AF23}" type="datetimeFigureOut">
              <a:rPr lang="en-US" smtClean="0"/>
              <a:t>1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7691A-B778-42F9-81EA-CDE7B8BA25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521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6CADE84-5C9C-4775-9927-B6EC06BB46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363" y="0"/>
            <a:ext cx="8657274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1E7ACFE-9711-4AAE-BE3A-3EB1F1BC8FD0}"/>
              </a:ext>
            </a:extLst>
          </p:cNvPr>
          <p:cNvSpPr txBox="1"/>
          <p:nvPr/>
        </p:nvSpPr>
        <p:spPr>
          <a:xfrm>
            <a:off x="8874" y="-8879"/>
            <a:ext cx="5095783" cy="3663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tabolomic Differences between Critically Ill Women and Men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wmya Chary, MBBS, </a:t>
            </a:r>
            <a:r>
              <a:rPr lang="en-US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MSc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Karin </a:t>
            </a:r>
            <a:r>
              <a:rPr lang="en-US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rein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D, MSc, Jessica A. Lasky-</a:t>
            </a:r>
            <a:r>
              <a:rPr lang="en-US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ScD, Harald </a:t>
            </a:r>
            <a:r>
              <a:rPr lang="en-US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obnig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MD, Kenneth B. Christopher, MD, SM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514087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neth christopher</dc:creator>
  <cp:lastModifiedBy>kenneth christopher</cp:lastModifiedBy>
  <cp:revision>4</cp:revision>
  <dcterms:created xsi:type="dcterms:W3CDTF">2020-04-19T00:57:58Z</dcterms:created>
  <dcterms:modified xsi:type="dcterms:W3CDTF">2020-12-01T15:57:15Z</dcterms:modified>
</cp:coreProperties>
</file>